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5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36087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51765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69700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86742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75955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58676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91520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02220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27793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00937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53734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842AD-0E39-45F0-9CAA-821D8144B8B5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ABC9D-51AC-4FD7-98ED-E5C2FB6B406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21433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526" y="1352117"/>
            <a:ext cx="6228948" cy="643976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8680" y="7956376"/>
            <a:ext cx="57606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Supplemental fig S6: Heat map for expression of selected genes involved in GLS biosynthesis in turnip. </a:t>
            </a:r>
            <a:endParaRPr lang="nl-NL" sz="1400" dirty="0"/>
          </a:p>
        </p:txBody>
      </p:sp>
    </p:spTree>
    <p:extLst>
      <p:ext uri="{BB962C8B-B14F-4D97-AF65-F5344CB8AC3E}">
        <p14:creationId xmlns:p14="http://schemas.microsoft.com/office/powerpoint/2010/main" val="1058849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ageningen University an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ekwilder, Jules</dc:creator>
  <cp:lastModifiedBy>Beekwilder, Jules</cp:lastModifiedBy>
  <cp:revision>4</cp:revision>
  <dcterms:created xsi:type="dcterms:W3CDTF">2017-12-22T15:27:32Z</dcterms:created>
  <dcterms:modified xsi:type="dcterms:W3CDTF">2019-05-22T15:42:08Z</dcterms:modified>
</cp:coreProperties>
</file>